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43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679" autoAdjust="0"/>
    <p:restoredTop sz="94660"/>
  </p:normalViewPr>
  <p:slideViewPr>
    <p:cSldViewPr snapToGrid="0">
      <p:cViewPr varScale="1">
        <p:scale>
          <a:sx n="61" d="100"/>
          <a:sy n="61" d="100"/>
        </p:scale>
        <p:origin x="96" y="119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17EBD81-DDCF-4394-9D53-15499AAC64DC}" type="datetimeFigureOut">
              <a:rPr lang="en-GB" smtClean="0"/>
              <a:t>21/05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04EFCC3-C08D-42E9-AE17-D801792739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3360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CD5166-24B3-4E19-B995-E052CAF2FD4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0A9420C-74C9-49BB-AD41-28EE86C5870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BC8B18-351C-48E0-9472-A630922949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21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E053A5-2EE6-4B5B-8C68-7AEFBAB58C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5936FA-2ECA-4E12-972C-072926AACB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58365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2DB603-F780-4278-B99F-10B213E58F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1824337-225E-4619-AD80-82B24D9805B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CBD175-7A87-4606-B941-02F2CC391D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21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C3B324-66A8-4E27-AB83-83D80A7147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3F7DD6-8B32-49D5-8C6C-67425064CF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03310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8758E29-E635-4399-9CD9-46327BC7CB5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36CAEA6-0304-4E7E-8DD9-4E7B3FDE731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822AF5-7E5B-41E4-BB84-26BB63BB62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21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7E407D-22C3-4181-9B8D-6F57882640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F47847-837C-4827-8211-DE386ABD20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40945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F984A5-DD37-4F65-A5C6-00D4914754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9A43F39-45A7-4064-9419-38FA43480AF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BCFF4C-3DBE-4D7D-9D82-2B7311D9B2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21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296C82-54D2-4335-B75E-98F7FD02AE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0A9AE4-4915-4B70-ADF9-8803E011B6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864574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1FF222-E43C-497F-A8A0-86E98E72D6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5078A5E-6C7F-4F2A-BC05-AF16FFE720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9085B8-86A9-4E5F-BBFC-BBD99D9D0A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21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B3B987-0B15-4835-9466-D378DC5DCF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1C07BE3-A330-4B3F-B8C8-221544BB30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56821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AC8D33-B9CE-4060-86FF-D1E63DF072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42BDDC4-9E2C-470E-8614-FEF2C0C06F9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13CA981-C392-4CD8-874B-E445CA860D3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F4B2A15-259B-4351-97D8-AED26DAA9D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21/05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A4A461E-7716-4F2C-A590-7E9C5F5BC1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360FD94-D0BF-4462-839C-302621E15F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00076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C4A57A-19A1-4077-8939-730B5FFA5B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C92A289-EDA8-44A2-BDF5-D7CF7A6889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992B2CC-1EE1-4F01-B2D8-3F59075915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E5D7109-7E5E-4123-A877-9B5072C05AD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279AE05-E585-4FEB-9FE4-5780487C8C3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FF49309-17B0-433A-86BE-A146548FAD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21/05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9FD9909-C228-4A80-8EE4-4220326047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67FB830-4967-4887-832C-6DE14DA726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05699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978A0D-C8D7-41CD-9131-0FBA2A421C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5EA9B54-893B-4E50-94CD-8053CD06B5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21/05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95BE61D-B329-4B2D-8E6C-4CBF322A26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AA6BEC3-86B4-447C-A9EA-F11ADA3D85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295888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314AE8A-D537-443B-97FE-D0A73B4506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21/05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0F0BA55-1FEE-4324-9EA5-0596C0B5DC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36D1075-0534-4C35-AA88-2767F45360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26442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58152F-F243-4D26-9E4A-DA17E8B265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5B3255A-4C51-4196-A55C-F8E6119A96C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D006397-CE0B-4D42-9B8A-296B2A0EA06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456B42B-99D5-45EE-8825-3C877B0339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21/05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71BCDF0-27C7-4BEF-BF33-BBB1F02D45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F0076C0-854F-47BF-8811-28B3A66756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51288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5E49C9-BFAD-446C-809A-6BA92E4238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636115C-F9B9-4CF2-BD07-B2ED49320CE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AC80B9A-0C94-4FDB-BD83-29C4D85B25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9D287A7-4E67-4825-8549-2CE233B7B7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21/05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39D5B43-1D10-44D7-9329-2D734A5E57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8DBA00B-0818-4388-9EC9-000329D2FD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10592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FCD8008-BD23-4FF3-B2C8-AEB1BFA1B9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6C2C572-2629-4EB6-8B9C-6F580C9A4F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729891-84FF-4E29-8D3C-97CDFD2F137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6E97E2-6761-46FF-B48E-E80B97A8F655}" type="datetimeFigureOut">
              <a:rPr lang="en-GB" smtClean="0"/>
              <a:t>21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F1E135-001E-4D84-A68E-E24216B85A3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25D331-C372-4209-83CA-16098BF2E6B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48439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25EFAEF1-BC79-E095-2E37-88D43D12690D}"/>
              </a:ext>
            </a:extLst>
          </p:cNvPr>
          <p:cNvSpPr txBox="1"/>
          <p:nvPr/>
        </p:nvSpPr>
        <p:spPr>
          <a:xfrm>
            <a:off x="43336" y="5954043"/>
            <a:ext cx="1182553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</a:t>
            </a:r>
            <a:r>
              <a:rPr lang="en-GB" sz="12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igure S2 A-D. </a:t>
            </a:r>
            <a:r>
              <a:rPr lang="en-GB" sz="12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Evaluation</a:t>
            </a:r>
            <a:r>
              <a:rPr lang="en-GB" sz="12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of </a:t>
            </a:r>
            <a:r>
              <a:rPr lang="en-GB" sz="12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LV</a:t>
            </a:r>
            <a:r>
              <a:rPr lang="en-GB" sz="12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insertion sites (IS) in iPSC </a:t>
            </a:r>
            <a:r>
              <a:rPr lang="en-GB" sz="12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day 3</a:t>
            </a:r>
            <a:r>
              <a:rPr lang="en-GB" sz="12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(early) and 30 day (late) </a:t>
            </a:r>
            <a:r>
              <a:rPr lang="en-GB" sz="12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nd HLC day 3</a:t>
            </a:r>
            <a:r>
              <a:rPr lang="en-GB" sz="12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GB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Normalised quantification of </a:t>
            </a:r>
            <a:r>
              <a:rPr lang="en-GB" sz="12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IS to show positioning of </a:t>
            </a:r>
            <a:r>
              <a:rPr lang="en-GB" sz="12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HV</a:t>
            </a:r>
            <a:r>
              <a:rPr lang="en-GB" sz="12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nd </a:t>
            </a:r>
            <a:r>
              <a:rPr lang="en-GB" sz="12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HR</a:t>
            </a:r>
            <a:r>
              <a:rPr lang="en-GB" sz="12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LV in regulatory regions in the transcription unit of genes after infection of iPSC and HLC. </a:t>
            </a:r>
            <a:r>
              <a:rPr lang="en-GB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ercentages represent normalised IS across the genome, including those outside transcriptional units</a:t>
            </a:r>
            <a:r>
              <a:rPr lang="en-GB" sz="12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(</a:t>
            </a:r>
            <a:r>
              <a:rPr lang="en-GB" sz="12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 and C</a:t>
            </a:r>
            <a:r>
              <a:rPr lang="en-GB" sz="12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. Similarly normalised IS in oncogenes and tumour suppressor genes are also shown (</a:t>
            </a:r>
            <a:r>
              <a:rPr lang="en-GB" sz="12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B and D</a:t>
            </a:r>
            <a:r>
              <a:rPr lang="en-GB" sz="12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. Notably, early sampled iPSC exhibit greater insertions. Values have been normalised to be represented as a proportion of all IS genes.</a:t>
            </a:r>
            <a:r>
              <a:rPr lang="en-GB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GB" sz="1200" dirty="0" err="1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.adj</a:t>
            </a:r>
            <a:r>
              <a:rPr lang="en-GB" sz="12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&lt;0.05 shown between samples demonstrating significance, denoted by </a:t>
            </a:r>
            <a:r>
              <a:rPr lang="en-GB" sz="12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sterix</a:t>
            </a:r>
            <a:r>
              <a:rPr lang="en-GB" sz="12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</a:t>
            </a:r>
            <a:endParaRPr lang="en-GB" sz="1200" dirty="0">
              <a:effectLst/>
              <a:highlight>
                <a:srgbClr val="FFFF00"/>
              </a:highlight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1E5943E7-DD28-3D26-639C-7550F7612FE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1166" t="22666" r="40651" b="10741"/>
          <a:stretch/>
        </p:blipFill>
        <p:spPr>
          <a:xfrm>
            <a:off x="2775374" y="104774"/>
            <a:ext cx="6069118" cy="58492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545055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694</TotalTime>
  <Words>132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qlain Suleman (Staff)</dc:creator>
  <cp:lastModifiedBy>Suleman, Saqlain</cp:lastModifiedBy>
  <cp:revision>34</cp:revision>
  <dcterms:created xsi:type="dcterms:W3CDTF">2024-01-05T10:52:35Z</dcterms:created>
  <dcterms:modified xsi:type="dcterms:W3CDTF">2025-05-21T15:42:47Z</dcterms:modified>
</cp:coreProperties>
</file>